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2BE043-55FD-4018-BFE7-FE851506C0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D32815-42B7-496B-B18C-E958653934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BD94E1-EE1D-409A-BBA8-0D33454BB77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ED68A2-E52E-4D4F-A9B6-32346C9196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4761AA-B670-4891-BA82-1C34243DDD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9E1841-8184-4265-8CA6-5A650A8806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703625-9A23-4C6A-B932-F9176C618F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941169-41E9-4EE8-A470-CA01E82960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B53AF9-CADA-44AB-940E-EE168C1A19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8973D6-BD39-4670-AE41-9503861AB6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58FFA8-4341-41E0-9FDF-C09A24F42C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B0F49C-29B1-4F99-9470-A276EF5A68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8BF5F9F-E1F8-4DAF-86C4-6F1F20B423F2}" type="datetime">
              <a:rPr b="0" lang="fr-FR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FB07905-FA64-4522-AEAD-FC650271D44F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5" descr="IGF"/>
          <p:cNvPicPr/>
          <p:nvPr/>
        </p:nvPicPr>
        <p:blipFill>
          <a:blip r:embed="rId1"/>
          <a:stretch/>
        </p:blipFill>
        <p:spPr>
          <a:xfrm>
            <a:off x="1407960" y="2895480"/>
            <a:ext cx="2000520" cy="519120"/>
          </a:xfrm>
          <a:prstGeom prst="rect">
            <a:avLst/>
          </a:prstGeom>
          <a:ln w="0">
            <a:noFill/>
          </a:ln>
        </p:spPr>
      </p:pic>
      <p:sp>
        <p:nvSpPr>
          <p:cNvPr id="42" name="Text Box 6"/>
          <p:cNvSpPr/>
          <p:nvPr/>
        </p:nvSpPr>
        <p:spPr>
          <a:xfrm>
            <a:off x="990720" y="3422520"/>
            <a:ext cx="32763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ICI          -      +        -       +        -       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INS        -       -        +       +       -        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IGF         -      -        -        -        +       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7"/>
          <p:cNvSpPr/>
          <p:nvPr/>
        </p:nvSpPr>
        <p:spPr>
          <a:xfrm>
            <a:off x="3475080" y="3156120"/>
            <a:ext cx="38088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8"/>
          <p:cNvSpPr/>
          <p:nvPr/>
        </p:nvSpPr>
        <p:spPr>
          <a:xfrm>
            <a:off x="3855960" y="3002040"/>
            <a:ext cx="1981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Calibri"/>
              </a:rPr>
              <a:t>P-AK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ZoneTexte 36"/>
          <p:cNvSpPr/>
          <p:nvPr/>
        </p:nvSpPr>
        <p:spPr>
          <a:xfrm>
            <a:off x="457200" y="2544840"/>
            <a:ext cx="8458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File.5 </a:t>
            </a:r>
            <a:r>
              <a:rPr b="1" lang="fr-FR" sz="12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Akt phosphorylation is equally induced  by IGF-I and insulin in cells exposed to ICI 182780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ZoneTexte 38"/>
          <p:cNvSpPr/>
          <p:nvPr/>
        </p:nvSpPr>
        <p:spPr>
          <a:xfrm>
            <a:off x="4597920" y="3314880"/>
            <a:ext cx="41277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Serum- and E2-starved cells exposed or not to ICI 1827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during 48 h were stimulated with IGF-I (10 nM) or insuli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(1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Symbol"/>
              </a:rPr>
              <a:t>m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M) for 1 h. The lysates were analyzed for phospho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Ser473 Ak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24T18:13:24Z</dcterms:created>
  <dc:creator>Anne-Marie</dc:creator>
  <dc:description/>
  <dc:language>en-US</dc:language>
  <cp:lastModifiedBy>Anne-Marie</cp:lastModifiedBy>
  <dcterms:modified xsi:type="dcterms:W3CDTF">2012-06-03T21:06:31Z</dcterms:modified>
  <cp:revision>5</cp:revision>
  <dc:subject/>
  <dc:title>Diapositive 1</dc:title>
</cp:coreProperties>
</file>